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4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26" y="3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63F1D-2991-4642-A342-BA131E13FA9C}" type="datetimeFigureOut">
              <a:rPr lang="en-US" smtClean="0"/>
              <a:t>10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CE288-DEC1-4F6A-B8A6-3B453F9A8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403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63F1D-2991-4642-A342-BA131E13FA9C}" type="datetimeFigureOut">
              <a:rPr lang="en-US" smtClean="0"/>
              <a:t>10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CE288-DEC1-4F6A-B8A6-3B453F9A8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768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63F1D-2991-4642-A342-BA131E13FA9C}" type="datetimeFigureOut">
              <a:rPr lang="en-US" smtClean="0"/>
              <a:t>10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CE288-DEC1-4F6A-B8A6-3B453F9A8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666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63F1D-2991-4642-A342-BA131E13FA9C}" type="datetimeFigureOut">
              <a:rPr lang="en-US" smtClean="0"/>
              <a:t>10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CE288-DEC1-4F6A-B8A6-3B453F9A8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783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63F1D-2991-4642-A342-BA131E13FA9C}" type="datetimeFigureOut">
              <a:rPr lang="en-US" smtClean="0"/>
              <a:t>10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CE288-DEC1-4F6A-B8A6-3B453F9A8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143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63F1D-2991-4642-A342-BA131E13FA9C}" type="datetimeFigureOut">
              <a:rPr lang="en-US" smtClean="0"/>
              <a:t>10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CE288-DEC1-4F6A-B8A6-3B453F9A8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604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63F1D-2991-4642-A342-BA131E13FA9C}" type="datetimeFigureOut">
              <a:rPr lang="en-US" smtClean="0"/>
              <a:t>10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CE288-DEC1-4F6A-B8A6-3B453F9A8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767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63F1D-2991-4642-A342-BA131E13FA9C}" type="datetimeFigureOut">
              <a:rPr lang="en-US" smtClean="0"/>
              <a:t>10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CE288-DEC1-4F6A-B8A6-3B453F9A8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690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63F1D-2991-4642-A342-BA131E13FA9C}" type="datetimeFigureOut">
              <a:rPr lang="en-US" smtClean="0"/>
              <a:t>10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CE288-DEC1-4F6A-B8A6-3B453F9A8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197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63F1D-2991-4642-A342-BA131E13FA9C}" type="datetimeFigureOut">
              <a:rPr lang="en-US" smtClean="0"/>
              <a:t>10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CE288-DEC1-4F6A-B8A6-3B453F9A8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7152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63F1D-2991-4642-A342-BA131E13FA9C}" type="datetimeFigureOut">
              <a:rPr lang="en-US" smtClean="0"/>
              <a:t>10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CE288-DEC1-4F6A-B8A6-3B453F9A8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092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B63F1D-2991-4642-A342-BA131E13FA9C}" type="datetimeFigureOut">
              <a:rPr lang="en-US" smtClean="0"/>
              <a:t>10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8CE288-DEC1-4F6A-B8A6-3B453F9A8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394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32"/>
          <a:stretch/>
        </p:blipFill>
        <p:spPr>
          <a:xfrm>
            <a:off x="2120254" y="807079"/>
            <a:ext cx="8404871" cy="5946145"/>
          </a:xfrm>
        </p:spPr>
      </p:pic>
      <p:sp>
        <p:nvSpPr>
          <p:cNvPr id="4" name="Rectangle 3"/>
          <p:cNvSpPr/>
          <p:nvPr/>
        </p:nvSpPr>
        <p:spPr>
          <a:xfrm>
            <a:off x="0" y="0"/>
            <a:ext cx="12192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ar plot showing relative expression of EHMT1 and genes co-expressed with EHMT1 (in </a:t>
            </a:r>
            <a:r>
              <a:rPr lang="en-US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apmap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U samples) between AH vs his parents </a:t>
            </a:r>
            <a:endParaRPr lang="en-US" dirty="0">
              <a:latin typeface="Cambria" panose="02040503050406030204" pitchFamily="18" charset="0"/>
              <a:ea typeface="MS Mincho"/>
              <a:cs typeface="Times New Roman" panose="02020603050405020304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6381750" y="6486525"/>
            <a:ext cx="247650" cy="1619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1106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0"/>
            <a:ext cx="12192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sychotropic drug profile of AH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dapted from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eneSight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ssureX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Health; https://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enesight.com)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[1. Lower doses required since Serum level too high; 4. Drug’s mechanism of action affected by genotype resulting in reduced efficacy; 6. Increased risk of side effects; 8. Potential drug-drug interaction identified (FDA drug label); 9. Contra-indicated for this genotype (FDA labe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]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4170" y="1200329"/>
            <a:ext cx="7037512" cy="56268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55092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02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Cambria</vt:lpstr>
      <vt:lpstr>MS Mincho</vt:lpstr>
      <vt:lpstr>Times New Roman</vt:lpstr>
      <vt:lpstr>Office Theme</vt:lpstr>
      <vt:lpstr>PowerPoint Presentation</vt:lpstr>
      <vt:lpstr>PowerPoint Presentation</vt:lpstr>
    </vt:vector>
  </TitlesOfParts>
  <Company>University of Minnesot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t K Mitra</dc:creator>
  <cp:lastModifiedBy>Amit K Mitra</cp:lastModifiedBy>
  <cp:revision>3</cp:revision>
  <dcterms:created xsi:type="dcterms:W3CDTF">2016-07-19T19:00:22Z</dcterms:created>
  <dcterms:modified xsi:type="dcterms:W3CDTF">2016-10-20T15:55:42Z</dcterms:modified>
</cp:coreProperties>
</file>